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6" r:id="rId5"/>
    <p:sldId id="262" r:id="rId6"/>
    <p:sldId id="263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03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57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31577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48250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907669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29574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697696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82626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88695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29851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70054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51343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34520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EFC8F-56AE-4278-8D31-9E0BB38D5EBD}" type="datetimeFigureOut">
              <a:rPr lang="nl-BE" smtClean="0"/>
              <a:t>12/06/2023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35C87-04EF-44E2-BFEB-FE5393EC0C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35175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3325" y="444137"/>
            <a:ext cx="2116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DAY 1, OPERATOR 1</a:t>
            </a:r>
            <a:endParaRPr lang="nl-BE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80492"/>
            <a:ext cx="6096000" cy="389701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480492"/>
            <a:ext cx="6096000" cy="3897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4576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83325" y="444137"/>
            <a:ext cx="2860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DAY 2 OPERATOR 1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887" y="1541416"/>
            <a:ext cx="6053944" cy="387013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9504" y="1541416"/>
            <a:ext cx="6053945" cy="3870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13551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6533" y="1502229"/>
            <a:ext cx="5877606" cy="375740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13954" y="418011"/>
            <a:ext cx="2129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DAY 1, OPERATOR 2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829" y="1502229"/>
            <a:ext cx="5895704" cy="3768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2136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16678"/>
            <a:ext cx="5982789" cy="382464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8062" y="169816"/>
            <a:ext cx="3069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DAY 2, OPERATOR 2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7018" y="1516678"/>
            <a:ext cx="5944982" cy="3800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38453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00891" y="30044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ROBUSTNESS, DAY 1</a:t>
            </a:r>
            <a:endParaRPr lang="nl-BE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1854926"/>
            <a:ext cx="6168692" cy="394348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0891" y="107768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90 MINUTES, NOT SHAKE, 4 ° C</a:t>
            </a:r>
            <a:endParaRPr lang="nl-BE" dirty="0"/>
          </a:p>
        </p:txBody>
      </p:sp>
      <p:sp>
        <p:nvSpPr>
          <p:cNvPr id="9" name="TextBox 8"/>
          <p:cNvSpPr txBox="1"/>
          <p:nvPr/>
        </p:nvSpPr>
        <p:spPr>
          <a:xfrm>
            <a:off x="7741919" y="107768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90 MINUTES, NOT SHAKE, 37 ° C</a:t>
            </a:r>
            <a:endParaRPr lang="nl-BE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8693" y="1854926"/>
            <a:ext cx="6023307" cy="3943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66129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0891" y="30044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ROBUSTNESS, DAY 1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600891" y="107768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90 MINUTES, SHAKE, 37 ° C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63485"/>
            <a:ext cx="6148257" cy="393042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003177" y="107768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3</a:t>
            </a:r>
            <a:r>
              <a:rPr lang="nl-BE" dirty="0" smtClean="0"/>
              <a:t>0 MINUTES, SHAKE, 4 ° C</a:t>
            </a:r>
            <a:endParaRPr lang="nl-BE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8257" y="1830299"/>
            <a:ext cx="6043743" cy="3863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65042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0891" y="126056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3</a:t>
            </a:r>
            <a:r>
              <a:rPr lang="nl-BE" dirty="0" smtClean="0"/>
              <a:t>0 MINUTES, NOT SHAKE, 37 ° C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600891" y="30044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ROBUSTNESS, DAY 1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51" y="1994125"/>
            <a:ext cx="6073549" cy="38826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55393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0891" y="30044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ROBUSTNESS, DAY 2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600891" y="1227909"/>
            <a:ext cx="3187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90 MIN, SHAKE, 4° C  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1826" y="1815737"/>
            <a:ext cx="6127826" cy="391736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977050" y="1227909"/>
            <a:ext cx="3187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3</a:t>
            </a:r>
            <a:r>
              <a:rPr lang="nl-BE" dirty="0" smtClean="0"/>
              <a:t>0 MIN, NOT SHAKE, 37° C  </a:t>
            </a:r>
            <a:endParaRPr lang="nl-BE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6346" y="1815737"/>
            <a:ext cx="6025654" cy="3852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82835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00891" y="300446"/>
            <a:ext cx="347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 smtClean="0"/>
              <a:t>ROBUSTNESS, DAY 2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888273" y="1280161"/>
            <a:ext cx="2416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3</a:t>
            </a:r>
            <a:r>
              <a:rPr lang="nl-BE" dirty="0" smtClean="0"/>
              <a:t>0 MIN, SHAKE, 37° C  </a:t>
            </a:r>
            <a:endParaRPr lang="nl-BE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44" y="2129246"/>
            <a:ext cx="6086956" cy="389123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421187" y="1280161"/>
            <a:ext cx="2695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3</a:t>
            </a:r>
            <a:r>
              <a:rPr lang="nl-BE" dirty="0" smtClean="0"/>
              <a:t>0 MIN, NOT SHAKE, 4° C  </a:t>
            </a:r>
            <a:endParaRPr lang="nl-BE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116183"/>
            <a:ext cx="6107389" cy="3904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6403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116</Words>
  <Application>Microsoft Office PowerPoint</Application>
  <PresentationFormat>Widescreen</PresentationFormat>
  <Paragraphs>1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eit Antwerp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nese Compagnone</dc:creator>
  <cp:lastModifiedBy>Agnese Compagnone</cp:lastModifiedBy>
  <cp:revision>10</cp:revision>
  <dcterms:created xsi:type="dcterms:W3CDTF">2023-06-12T07:30:50Z</dcterms:created>
  <dcterms:modified xsi:type="dcterms:W3CDTF">2023-06-12T09:37:58Z</dcterms:modified>
</cp:coreProperties>
</file>